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4"/>
  </p:notesMasterIdLst>
  <p:sldIdLst>
    <p:sldId id="313" r:id="rId2"/>
    <p:sldId id="302" r:id="rId3"/>
    <p:sldId id="362" r:id="rId4"/>
    <p:sldId id="259" r:id="rId5"/>
    <p:sldId id="285" r:id="rId6"/>
    <p:sldId id="260" r:id="rId7"/>
    <p:sldId id="261" r:id="rId8"/>
    <p:sldId id="274" r:id="rId9"/>
    <p:sldId id="273" r:id="rId10"/>
    <p:sldId id="292" r:id="rId11"/>
    <p:sldId id="297" r:id="rId12"/>
    <p:sldId id="299" r:id="rId13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14" autoAdjust="0"/>
    <p:restoredTop sz="94660"/>
  </p:normalViewPr>
  <p:slideViewPr>
    <p:cSldViewPr snapToGrid="0">
      <p:cViewPr varScale="1">
        <p:scale>
          <a:sx n="69" d="100"/>
          <a:sy n="69" d="100"/>
        </p:scale>
        <p:origin x="696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A571D678-3A2C-47B3-A481-542585A04E6E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1162050"/>
            <a:ext cx="55753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914C8856-4496-429D-80C4-D36EB2FCA7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34008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873ED-3B9D-42A9-9FE7-2E3A89E87F7D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FA8FD-B3D8-4060-BC06-B8B43C96DA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08928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873ED-3B9D-42A9-9FE7-2E3A89E87F7D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FA8FD-B3D8-4060-BC06-B8B43C96DA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97015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873ED-3B9D-42A9-9FE7-2E3A89E87F7D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FA8FD-B3D8-4060-BC06-B8B43C96DA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10161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873ED-3B9D-42A9-9FE7-2E3A89E87F7D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FA8FD-B3D8-4060-BC06-B8B43C96DA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06852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873ED-3B9D-42A9-9FE7-2E3A89E87F7D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FA8FD-B3D8-4060-BC06-B8B43C96DA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46144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873ED-3B9D-42A9-9FE7-2E3A89E87F7D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FA8FD-B3D8-4060-BC06-B8B43C96DA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82963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873ED-3B9D-42A9-9FE7-2E3A89E87F7D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FA8FD-B3D8-4060-BC06-B8B43C96DA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75752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873ED-3B9D-42A9-9FE7-2E3A89E87F7D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FA8FD-B3D8-4060-BC06-B8B43C96DA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34770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873ED-3B9D-42A9-9FE7-2E3A89E87F7D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FA8FD-B3D8-4060-BC06-B8B43C96DA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69601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873ED-3B9D-42A9-9FE7-2E3A89E87F7D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FA8FD-B3D8-4060-BC06-B8B43C96DA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88907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873ED-3B9D-42A9-9FE7-2E3A89E87F7D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7FA8FD-B3D8-4060-BC06-B8B43C96DA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50315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C873ED-3B9D-42A9-9FE7-2E3A89E87F7D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7FA8FD-B3D8-4060-BC06-B8B43C96DA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95086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pselvar@emory.edu" TargetMode="External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oleObject" Target="../embeddings/oleObject8.bin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oleObject" Target="../embeddings/oleObject9.bin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7" Type="http://schemas.openxmlformats.org/officeDocument/2006/relationships/image" Target="../media/image15.emf"/><Relationship Id="rId2" Type="http://schemas.openxmlformats.org/officeDocument/2006/relationships/oleObject" Target="../embeddings/oleObject10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12.bin"/><Relationship Id="rId5" Type="http://schemas.openxmlformats.org/officeDocument/2006/relationships/image" Target="../media/image14.emf"/><Relationship Id="rId4" Type="http://schemas.openxmlformats.org/officeDocument/2006/relationships/oleObject" Target="../embeddings/oleObject11.bin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oleObject" Target="../embeddings/oleObject2.bin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oleObject" Target="../embeddings/oleObject3.bin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oleObject" Target="../embeddings/oleObject4.bin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oleObject" Target="../embeddings/oleObject5.bin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oleObject" Target="../embeddings/oleObject6.bin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0.emf"/><Relationship Id="rId4" Type="http://schemas.openxmlformats.org/officeDocument/2006/relationships/oleObject" Target="../embeddings/oleObject7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777922" y="321808"/>
            <a:ext cx="11095630" cy="63094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b="1" u="sng" dirty="0">
                <a:latin typeface="Times New Roman" panose="02020603050405020304" pitchFamily="18" charset="0"/>
                <a:ea typeface="Calibri" panose="020F0502020204030204" pitchFamily="34" charset="0"/>
              </a:rPr>
              <a:t>Title:  Influenza virus-like particle-based hybrid vaccine containing RBD induces immunity against influenza and SARS-CoV-2 viruses </a:t>
            </a:r>
            <a:r>
              <a:rPr lang="en-US" sz="2000" b="1" kern="14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 </a:t>
            </a:r>
          </a:p>
          <a:p>
            <a:pPr algn="ctr">
              <a:lnSpc>
                <a:spcPct val="150000"/>
              </a:lnSpc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Authors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: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Ramireddy Bommireddy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1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, Shannon Stone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2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, 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</a:rPr>
              <a:t>Noopur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 Bhatnagar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3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,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</a:rPr>
              <a:t>Pratima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Kumari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2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Luis E. Munoz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1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, Judy Oh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3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, Ki-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</a:rPr>
              <a:t>Hye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 Kim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3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, Jameson T. L. Berry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1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, Kristen M. Jacobsen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4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, 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</a:rPr>
              <a:t>Lahcen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 Jaafar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4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, 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</a:rPr>
              <a:t>Swe-Htet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 Naing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4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, Allison N. Blackerby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4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, Tori Van der Gaag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4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, Chloe N. Wright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4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, 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</a:rPr>
              <a:t>Lilin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 Lai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5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, Christopher D. Pack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4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, Sampath Ramachandiran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4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, 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</a:rPr>
              <a:t>Mehul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 S. Suthar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5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, Sang-Moo Kang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3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, Mukesh Kumar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2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, Shaker J. C. Reddy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4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, and Periasamy Selvaraj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1*</a:t>
            </a:r>
            <a:endParaRPr lang="en-US" sz="1200" dirty="0"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Affiliations: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1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Dept of Pathology and Laboratory Medicine, Emory University School of Medicine, Atlanta, GA 30322</a:t>
            </a:r>
            <a:endParaRPr lang="en-US" sz="1200" dirty="0"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2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Department of Biology, College of Arts and Sciences, Georgia State University, Atlanta, GA 30303, USA. </a:t>
            </a:r>
            <a:endParaRPr lang="en-US" sz="1200" dirty="0"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3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Institute for Biomedical Sciences, Georgia State University, Atlanta, GA 30303, USA. </a:t>
            </a:r>
            <a:endParaRPr lang="en-US" sz="1200" dirty="0"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4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Metaclipse Therapeutics Corporation, Atlanta, GA 30340</a:t>
            </a:r>
            <a:endParaRPr lang="en-US" sz="1200" dirty="0"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5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Department of Pediatrics, Yerkes Primate research Center, Emory Vaccine Center, Emory University School of Medicine, Atlanta, GA 30322</a:t>
            </a:r>
            <a:endParaRPr lang="en-US" sz="1200" dirty="0"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*Corresponding author. Email:  </a:t>
            </a:r>
            <a:r>
              <a:rPr lang="en-US" sz="1200" u="sng" dirty="0">
                <a:solidFill>
                  <a:srgbClr val="0000FF"/>
                </a:solidFill>
                <a:latin typeface="Times New Roman" panose="02020603050405020304" pitchFamily="18" charset="0"/>
                <a:ea typeface="Calibri" panose="020F0502020204030204" pitchFamily="34" charset="0"/>
                <a:hlinkClick r:id="rId2"/>
              </a:rPr>
              <a:t>pselvar@emory.edu</a:t>
            </a:r>
            <a:endParaRPr lang="en-US" sz="1200" dirty="0"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pPr>
              <a:lnSpc>
                <a:spcPct val="150000"/>
              </a:lnSpc>
              <a:spcBef>
                <a:spcPts val="600"/>
              </a:spcBef>
            </a:pPr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Materials &amp; Methods</a:t>
            </a:r>
            <a:endParaRPr lang="en-US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8269437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13924824"/>
              </p:ext>
            </p:extLst>
          </p:nvPr>
        </p:nvGraphicFramePr>
        <p:xfrm>
          <a:off x="3514725" y="427038"/>
          <a:ext cx="4308475" cy="3619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3933402" imgH="3304053" progId="Prism9.Document">
                  <p:embed/>
                </p:oleObj>
              </mc:Choice>
              <mc:Fallback>
                <p:oleObj name="Prism 9" r:id="rId2" imgW="3933402" imgH="3304053" progId="Prism9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514725" y="427038"/>
                        <a:ext cx="4308475" cy="36195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1119116" y="4111469"/>
            <a:ext cx="10480059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9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GPI-RBD-GM-CSF fusion protein but not RBD-His induces antibody response against RBD.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Mice administered with GPI-RBD-GM-CSF or VLP vaccine containing GPI-RBD-GM-CSF with or without GPI-IL-12 intramuscularly. Blood was collected after 2 weeks (week 2), and the following day booster dose was given. Blood collected 2 weeks after the booster dose (week 4: 4 weeks after the first dose). CHO S cell transfectants expressing GPI-RBD-GM-CSF used for detection of anti-RBD antibody by flow cytometry. FITC-conjugated anti-mouse IgM/IgG secondary antibody used. RBD from Ray Biotech (1.0 µg) was used as a control protein antigen. Sera dilution is 100x. 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Note: No detectable antibody in mice administered with RBD-His (RBD with Histidine tag)  from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RayBiotech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(purple color).</a:t>
            </a:r>
          </a:p>
        </p:txBody>
      </p:sp>
      <p:sp>
        <p:nvSpPr>
          <p:cNvPr id="6" name="Right Brace 5"/>
          <p:cNvSpPr/>
          <p:nvPr/>
        </p:nvSpPr>
        <p:spPr>
          <a:xfrm>
            <a:off x="6919417" y="545905"/>
            <a:ext cx="204717" cy="614149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/>
          <p:cNvSpPr txBox="1"/>
          <p:nvPr/>
        </p:nvSpPr>
        <p:spPr>
          <a:xfrm>
            <a:off x="7246966" y="626684"/>
            <a:ext cx="17461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urified proteins</a:t>
            </a:r>
          </a:p>
        </p:txBody>
      </p:sp>
      <p:sp>
        <p:nvSpPr>
          <p:cNvPr id="8" name="Right Brace 7"/>
          <p:cNvSpPr/>
          <p:nvPr/>
        </p:nvSpPr>
        <p:spPr>
          <a:xfrm>
            <a:off x="7290183" y="1298809"/>
            <a:ext cx="204717" cy="614149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/>
          <p:cNvSpPr txBox="1"/>
          <p:nvPr/>
        </p:nvSpPr>
        <p:spPr>
          <a:xfrm>
            <a:off x="7683694" y="1421217"/>
            <a:ext cx="12825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VLP vaccine</a:t>
            </a:r>
          </a:p>
        </p:txBody>
      </p:sp>
    </p:spTree>
    <p:extLst>
      <p:ext uri="{BB962C8B-B14F-4D97-AF65-F5344CB8AC3E}">
        <p14:creationId xmlns:p14="http://schemas.microsoft.com/office/powerpoint/2010/main" val="396742706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129051" y="4416366"/>
            <a:ext cx="9144000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10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Hybrid vaccine induces antibody response against influenza VLP antigens.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ELISA plates coated with influenza VLP. Serum samples (12 weeks after first dose) from mice immunized with VLP RG (hybrid vaccine without GPI-IL-12) or hybrid vaccine were diluted 5000 times and added to the wells after blocking the plates. Total IgG and isotype specific anti-mouse IgG-HRP conjugate used to detect the bound antibody.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Hybrid vaccine: VLP incorporated with GPI-RBD-GM-CSF and GPI-IL-12</a:t>
            </a:r>
          </a:p>
        </p:txBody>
      </p:sp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82790826"/>
              </p:ext>
            </p:extLst>
          </p:nvPr>
        </p:nvGraphicFramePr>
        <p:xfrm>
          <a:off x="4133850" y="855663"/>
          <a:ext cx="3835400" cy="33464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3210610" imgH="2799117" progId="Prism9.Document">
                  <p:embed/>
                </p:oleObj>
              </mc:Choice>
              <mc:Fallback>
                <p:oleObj name="Prism 9" r:id="rId2" imgW="3210610" imgH="2799117" progId="Prism9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133850" y="855663"/>
                        <a:ext cx="3835400" cy="33464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067172345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18300541"/>
              </p:ext>
            </p:extLst>
          </p:nvPr>
        </p:nvGraphicFramePr>
        <p:xfrm>
          <a:off x="5129213" y="1193800"/>
          <a:ext cx="3033712" cy="27082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2544359" imgH="2275498" progId="Prism9.Document">
                  <p:embed/>
                </p:oleObj>
              </mc:Choice>
              <mc:Fallback>
                <p:oleObj name="Prism 9" r:id="rId2" imgW="2544359" imgH="2275498" progId="Prism9.Document">
                  <p:embed/>
                  <p:pic>
                    <p:nvPicPr>
                      <p:cNvPr id="7" name="Object 6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129213" y="1193800"/>
                        <a:ext cx="3033712" cy="27082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564201" y="4470959"/>
            <a:ext cx="10210636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S11</a:t>
            </a:r>
            <a:r>
              <a:rPr lang="en-US" dirty="0"/>
              <a:t>. </a:t>
            </a:r>
            <a:r>
              <a:rPr lang="en-US" b="1" dirty="0"/>
              <a:t>Hybrid vaccine induces antibody response against RBD-GM-CSF and influenza VLP antigens. </a:t>
            </a:r>
            <a:r>
              <a:rPr lang="en-US" dirty="0"/>
              <a:t>ELISA plates coated with GPI-RBD-GM-CSF, influenza VLP or recombinant GM-CSF as indicated. Serum samples (2 weeks after the booster dose) from mice immunized with PBS, VLP, hybrid vaccine or hybrid vaccine without IL-12 (A) or hybrid vaccine (B &amp; C) were diluted and added to the wells after blocking the plates. Anti-mouse IgG-HRP conjugate used to detect the bound IgG antibody.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69250940"/>
              </p:ext>
            </p:extLst>
          </p:nvPr>
        </p:nvGraphicFramePr>
        <p:xfrm>
          <a:off x="729397" y="1359303"/>
          <a:ext cx="4625975" cy="30337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4009751" imgH="2726006" progId="Prism9.Document">
                  <p:embed/>
                </p:oleObj>
              </mc:Choice>
              <mc:Fallback>
                <p:oleObj name="Prism 9" r:id="rId4" imgW="4009751" imgH="2726006" progId="Prism9.Document">
                  <p:embed/>
                  <p:pic>
                    <p:nvPicPr>
                      <p:cNvPr id="23" name="Object 22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729397" y="1359303"/>
                        <a:ext cx="4625975" cy="30337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1574136" y="1201001"/>
            <a:ext cx="316785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oating antigen: GPI-RBD-GM-CSF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B29C0CB-C922-4385-B2CC-ED7873DE1FA6}"/>
              </a:ext>
            </a:extLst>
          </p:cNvPr>
          <p:cNvSpPr txBox="1"/>
          <p:nvPr/>
        </p:nvSpPr>
        <p:spPr>
          <a:xfrm>
            <a:off x="993000" y="941153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9FCD04E-76AC-4826-91C9-8181F2CB0FA6}"/>
              </a:ext>
            </a:extLst>
          </p:cNvPr>
          <p:cNvSpPr txBox="1"/>
          <p:nvPr/>
        </p:nvSpPr>
        <p:spPr>
          <a:xfrm>
            <a:off x="4922578" y="941153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B</a:t>
            </a:r>
          </a:p>
        </p:txBody>
      </p:sp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1FE41E7A-C65D-4D97-AE43-913FFABF805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89225777"/>
              </p:ext>
            </p:extLst>
          </p:nvPr>
        </p:nvGraphicFramePr>
        <p:xfrm>
          <a:off x="8034960" y="1273107"/>
          <a:ext cx="2990488" cy="255681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2598019" imgH="2222211" progId="Prism9.Document">
                  <p:embed/>
                </p:oleObj>
              </mc:Choice>
              <mc:Fallback>
                <p:oleObj name="Prism 9" r:id="rId6" imgW="2598019" imgH="2222211" progId="Prism9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8034960" y="1273107"/>
                        <a:ext cx="2990488" cy="255681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53799F8B-548D-490E-94EC-D4D4FE1C939D}"/>
              </a:ext>
            </a:extLst>
          </p:cNvPr>
          <p:cNvSpPr txBox="1"/>
          <p:nvPr/>
        </p:nvSpPr>
        <p:spPr>
          <a:xfrm>
            <a:off x="9008434" y="1242831"/>
            <a:ext cx="16433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oating antigen: 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2CDCA9B-B087-4966-BD83-ED6CD75C43CA}"/>
              </a:ext>
            </a:extLst>
          </p:cNvPr>
          <p:cNvSpPr txBox="1"/>
          <p:nvPr/>
        </p:nvSpPr>
        <p:spPr>
          <a:xfrm>
            <a:off x="6087699" y="1046443"/>
            <a:ext cx="16433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oating antigen: 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216D31D-9A99-4EC8-A46F-93D1B5F9E6C0}"/>
              </a:ext>
            </a:extLst>
          </p:cNvPr>
          <p:cNvSpPr txBox="1"/>
          <p:nvPr/>
        </p:nvSpPr>
        <p:spPr>
          <a:xfrm>
            <a:off x="8195255" y="941153"/>
            <a:ext cx="3481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100527935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1669A4A-9DF1-4CAC-8127-74161881F218}"/>
              </a:ext>
            </a:extLst>
          </p:cNvPr>
          <p:cNvSpPr txBox="1"/>
          <p:nvPr/>
        </p:nvSpPr>
        <p:spPr>
          <a:xfrm>
            <a:off x="1933431" y="3947926"/>
            <a:ext cx="7206018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S1. Purified GPI-RBD-GM-CSF fusion protein blocks binding of MM57 mAb to CHO-S cells expressing GPI-RBD-GM-CSF.  </a:t>
            </a:r>
            <a:r>
              <a:rPr lang="en-US" dirty="0"/>
              <a:t>MM57 mAb (0.25 µg/ml) mixed with 3 µg/ml RBD (Ray Biotech; dark green) or GPI-RBD-GM-CSF fusion protein (light green)  for 1 </a:t>
            </a:r>
            <a:r>
              <a:rPr lang="en-US" dirty="0" err="1"/>
              <a:t>hr</a:t>
            </a:r>
            <a:r>
              <a:rPr lang="en-US" dirty="0"/>
              <a:t> at room temperature in FACS buffer and then added to CHO-S cells and incubated for 1 </a:t>
            </a:r>
            <a:r>
              <a:rPr lang="en-US" dirty="0" err="1"/>
              <a:t>hr</a:t>
            </a:r>
            <a:r>
              <a:rPr lang="en-US" dirty="0"/>
              <a:t> at 4</a:t>
            </a:r>
            <a:r>
              <a:rPr lang="en-US" baseline="30000" dirty="0"/>
              <a:t>o</a:t>
            </a:r>
            <a:r>
              <a:rPr lang="en-US" dirty="0"/>
              <a:t>C. Washed the cells with FACS buffer 2 times and then incubated with FITC-conjugated secondary antibody for flow cytometry analysis.</a:t>
            </a:r>
          </a:p>
          <a:p>
            <a:r>
              <a:rPr lang="en-US" dirty="0"/>
              <a:t> </a:t>
            </a: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2"/>
          <a:srcRect b="20847"/>
          <a:stretch/>
        </p:blipFill>
        <p:spPr>
          <a:xfrm>
            <a:off x="1923056" y="683233"/>
            <a:ext cx="4219575" cy="3083550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6B7DB72A-409C-4E02-B16D-1C90FE438C71}"/>
              </a:ext>
            </a:extLst>
          </p:cNvPr>
          <p:cNvSpPr txBox="1"/>
          <p:nvPr/>
        </p:nvSpPr>
        <p:spPr>
          <a:xfrm>
            <a:off x="3311263" y="2824209"/>
            <a:ext cx="12538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  <a:r>
              <a:rPr lang="en-US" baseline="30000" dirty="0"/>
              <a:t>o</a:t>
            </a:r>
            <a:r>
              <a:rPr lang="en-US" dirty="0"/>
              <a:t>Ab alone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5E22168-9266-4A8C-8543-C53814A59B14}"/>
              </a:ext>
            </a:extLst>
          </p:cNvPr>
          <p:cNvSpPr txBox="1"/>
          <p:nvPr/>
        </p:nvSpPr>
        <p:spPr>
          <a:xfrm>
            <a:off x="4120052" y="2457187"/>
            <a:ext cx="7152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MM57 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9128DD1-F82D-45D3-A910-C41228B80138}"/>
              </a:ext>
            </a:extLst>
          </p:cNvPr>
          <p:cNvSpPr txBox="1"/>
          <p:nvPr/>
        </p:nvSpPr>
        <p:spPr>
          <a:xfrm>
            <a:off x="3919501" y="1815282"/>
            <a:ext cx="148501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MM57+</a:t>
            </a:r>
          </a:p>
          <a:p>
            <a:r>
              <a:rPr lang="en-US" sz="1400" dirty="0"/>
              <a:t>GPI-RBD-GM-CSF 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B77452D-D994-45B3-984F-8D8A3E83F5C8}"/>
              </a:ext>
            </a:extLst>
          </p:cNvPr>
          <p:cNvSpPr txBox="1"/>
          <p:nvPr/>
        </p:nvSpPr>
        <p:spPr>
          <a:xfrm>
            <a:off x="3611831" y="1093978"/>
            <a:ext cx="148334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MM57+ </a:t>
            </a:r>
          </a:p>
          <a:p>
            <a:r>
              <a:rPr lang="en-US" sz="1400" dirty="0"/>
              <a:t>RBD (</a:t>
            </a:r>
            <a:r>
              <a:rPr lang="en-US" sz="1400" dirty="0" err="1"/>
              <a:t>RayBio</a:t>
            </a:r>
            <a:r>
              <a:rPr lang="en-US" sz="1400" dirty="0"/>
              <a:t>) </a:t>
            </a:r>
          </a:p>
        </p:txBody>
      </p:sp>
      <p:graphicFrame>
        <p:nvGraphicFramePr>
          <p:cNvPr id="15" name="Object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53093126"/>
              </p:ext>
            </p:extLst>
          </p:nvPr>
        </p:nvGraphicFramePr>
        <p:xfrm>
          <a:off x="5219700" y="928688"/>
          <a:ext cx="3611563" cy="23193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3611801" imgH="2319032" progId="Prism9.Document">
                  <p:embed/>
                </p:oleObj>
              </mc:Choice>
              <mc:Fallback>
                <p:oleObj name="Prism 9" r:id="rId3" imgW="3611801" imgH="2319032" progId="Prism9.Document">
                  <p:embed/>
                  <p:pic>
                    <p:nvPicPr>
                      <p:cNvPr id="22" name="Object 2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219700" y="928688"/>
                        <a:ext cx="3611563" cy="23193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74244331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6A805CAC-FFE7-46A5-9CD6-C9C72B58C3C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28272758"/>
              </p:ext>
            </p:extLst>
          </p:nvPr>
        </p:nvGraphicFramePr>
        <p:xfrm>
          <a:off x="2283114" y="1504466"/>
          <a:ext cx="3212713" cy="298589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6160842" imgH="5726449" progId="Prism9.Document">
                  <p:embed/>
                </p:oleObj>
              </mc:Choice>
              <mc:Fallback>
                <p:oleObj name="Prism 9" r:id="rId2" imgW="6160842" imgH="5726449" progId="Prism9.Document">
                  <p:embed/>
                  <p:pic>
                    <p:nvPicPr>
                      <p:cNvPr id="42" name="Object 41">
                        <a:extLst>
                          <a:ext uri="{FF2B5EF4-FFF2-40B4-BE49-F238E27FC236}">
                            <a16:creationId xmlns:a16="http://schemas.microsoft.com/office/drawing/2014/main" id="{84CF2B8A-8212-4BF4-8261-BA65E21829F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283114" y="1504466"/>
                        <a:ext cx="3212713" cy="298589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752E71E4-E1FE-4DB1-990A-0D51F3C0418B}"/>
              </a:ext>
            </a:extLst>
          </p:cNvPr>
          <p:cNvSpPr txBox="1"/>
          <p:nvPr/>
        </p:nvSpPr>
        <p:spPr>
          <a:xfrm>
            <a:off x="5383641" y="1504466"/>
            <a:ext cx="5834256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S2. Purified GPI-RBD-GM-CSF fusion protein and VLP vaccine incorporated with GPI-RBD-GM-CSF induce BMDC proliferation.  </a:t>
            </a:r>
            <a:r>
              <a:rPr lang="en-GB" dirty="0"/>
              <a:t>BMDCs of female BALB/c mice were cultured in complete RPMI-1640 medium containing various concentrations of recombinant murine GM-CSF (</a:t>
            </a:r>
            <a:r>
              <a:rPr lang="en-GB" dirty="0" err="1"/>
              <a:t>rGM</a:t>
            </a:r>
            <a:r>
              <a:rPr lang="en-GB" dirty="0"/>
              <a:t>-CSF, </a:t>
            </a:r>
            <a:r>
              <a:rPr lang="en-GB" dirty="0" err="1"/>
              <a:t>BioLegend</a:t>
            </a:r>
            <a:r>
              <a:rPr lang="en-GB" dirty="0"/>
              <a:t>, San Diego, CA, USA), GPI-GM-CSF, GPI-RBD-GM-CSF or VLPs incorporated with GPI-RBD-GM-CSF at a density of 2 × 10</a:t>
            </a:r>
            <a:r>
              <a:rPr lang="en-GB" baseline="30000" dirty="0"/>
              <a:t>5</a:t>
            </a:r>
            <a:r>
              <a:rPr lang="en-GB" dirty="0"/>
              <a:t> cells/</a:t>
            </a:r>
            <a:r>
              <a:rPr lang="en-GB" dirty="0" err="1"/>
              <a:t>mL.</a:t>
            </a:r>
            <a:r>
              <a:rPr lang="en-GB" dirty="0"/>
              <a:t> After 3 days of culture, XTT assay reagent added, and absorbance measured after 3 hours at 480 nm and 660 nm for background reference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2298324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850308" y="1740668"/>
            <a:ext cx="5889182" cy="1675746"/>
            <a:chOff x="1699934" y="1740668"/>
            <a:chExt cx="5889182" cy="1697254"/>
          </a:xfrm>
        </p:grpSpPr>
        <p:cxnSp>
          <p:nvCxnSpPr>
            <p:cNvPr id="3" name="Straight Connector 2"/>
            <p:cNvCxnSpPr>
              <a:cxnSpLocks/>
            </p:cNvCxnSpPr>
            <p:nvPr/>
          </p:nvCxnSpPr>
          <p:spPr>
            <a:xfrm>
              <a:off x="1948714" y="2332708"/>
              <a:ext cx="5237919" cy="176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7" name="Group 6"/>
            <p:cNvGrpSpPr/>
            <p:nvPr/>
          </p:nvGrpSpPr>
          <p:grpSpPr>
            <a:xfrm>
              <a:off x="1699934" y="1740668"/>
              <a:ext cx="5889182" cy="1697254"/>
              <a:chOff x="1379839" y="237854"/>
              <a:chExt cx="5889182" cy="1697254"/>
            </a:xfrm>
          </p:grpSpPr>
          <p:grpSp>
            <p:nvGrpSpPr>
              <p:cNvPr id="9" name="Group 15"/>
              <p:cNvGrpSpPr>
                <a:grpSpLocks/>
              </p:cNvGrpSpPr>
              <p:nvPr/>
            </p:nvGrpSpPr>
            <p:grpSpPr bwMode="auto">
              <a:xfrm>
                <a:off x="1379839" y="237854"/>
                <a:ext cx="5099575" cy="1317535"/>
                <a:chOff x="1440398" y="5462292"/>
                <a:chExt cx="4579401" cy="1206175"/>
              </a:xfrm>
            </p:grpSpPr>
            <p:grpSp>
              <p:nvGrpSpPr>
                <p:cNvPr id="19" name="Group 12"/>
                <p:cNvGrpSpPr>
                  <a:grpSpLocks/>
                </p:cNvGrpSpPr>
                <p:nvPr/>
              </p:nvGrpSpPr>
              <p:grpSpPr bwMode="auto">
                <a:xfrm>
                  <a:off x="1483011" y="6203207"/>
                  <a:ext cx="4536788" cy="465260"/>
                  <a:chOff x="1483011" y="5821964"/>
                  <a:chExt cx="4536788" cy="464952"/>
                </a:xfrm>
              </p:grpSpPr>
              <p:sp>
                <p:nvSpPr>
                  <p:cNvPr id="24" name="TextBox 9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483011" y="5821964"/>
                    <a:ext cx="1545480" cy="28519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=""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=""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5pPr>
                    <a:lvl6pPr marL="25146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6pPr>
                    <a:lvl7pPr marL="29718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7pPr>
                    <a:lvl8pPr marL="34290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8pPr>
                    <a:lvl9pPr marL="38862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9pPr>
                  </a:lstStyle>
                  <a:p>
                    <a:r>
                      <a:rPr lang="en-US" sz="1400" b="1" dirty="0">
                        <a:ea typeface="MS PGothic" charset="0"/>
                        <a:cs typeface="MS PGothic" charset="0"/>
                      </a:rPr>
                      <a:t>prime:</a:t>
                    </a:r>
                  </a:p>
                </p:txBody>
              </p:sp>
              <p:sp>
                <p:nvSpPr>
                  <p:cNvPr id="25" name="TextBox 24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2443928" y="5845776"/>
                    <a:ext cx="1032695" cy="28519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=""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=""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5pPr>
                    <a:lvl6pPr marL="25146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6pPr>
                    <a:lvl7pPr marL="29718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7pPr>
                    <a:lvl8pPr marL="34290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8pPr>
                    <a:lvl9pPr marL="38862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9pPr>
                  </a:lstStyle>
                  <a:p>
                    <a:r>
                      <a:rPr lang="en-US" sz="1400" b="1" dirty="0">
                        <a:ea typeface="MS PGothic" charset="0"/>
                        <a:cs typeface="MS PGothic" charset="0"/>
                      </a:rPr>
                      <a:t>Boost:</a:t>
                    </a:r>
                  </a:p>
                </p:txBody>
              </p:sp>
              <p:sp>
                <p:nvSpPr>
                  <p:cNvPr id="26" name="TextBox 25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4267199" y="5948588"/>
                    <a:ext cx="1752600" cy="33832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=""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=""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>
                    <a:spAutoFit/>
                  </a:bodyPr>
                  <a:lstStyle>
                    <a:lvl1pPr>
                      <a:defRPr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1pPr>
                    <a:lvl2pPr marL="742950" indent="-285750">
                      <a:defRPr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2pPr>
                    <a:lvl3pPr marL="1143000" indent="-228600">
                      <a:defRPr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3pPr>
                    <a:lvl4pPr marL="1600200" indent="-228600">
                      <a:defRPr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4pPr>
                    <a:lvl5pPr marL="2057400" indent="-228600">
                      <a:defRPr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5pPr>
                    <a:lvl6pPr marL="25146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6pPr>
                    <a:lvl7pPr marL="29718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7pPr>
                    <a:lvl8pPr marL="34290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8pPr>
                    <a:lvl9pPr marL="3886200" indent="-228600" fontAlgn="base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charset="0"/>
                        <a:ea typeface="ＭＳ Ｐゴシック" charset="0"/>
                      </a:defRPr>
                    </a:lvl9pPr>
                  </a:lstStyle>
                  <a:p>
                    <a:endParaRPr lang="en-US" sz="1600" b="1" dirty="0">
                      <a:ea typeface="MS PGothic" charset="0"/>
                      <a:cs typeface="MS PGothic" charset="0"/>
                    </a:endParaRPr>
                  </a:p>
                </p:txBody>
              </p:sp>
            </p:grpSp>
            <p:sp>
              <p:nvSpPr>
                <p:cNvPr id="20" name="TextBox 16"/>
                <p:cNvSpPr txBox="1">
                  <a:spLocks noChangeArrowheads="1"/>
                </p:cNvSpPr>
                <p:nvPr/>
              </p:nvSpPr>
              <p:spPr bwMode="auto">
                <a:xfrm>
                  <a:off x="1440398" y="5497165"/>
                  <a:ext cx="590381" cy="28176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9pPr>
                </a:lstStyle>
                <a:p>
                  <a:r>
                    <a:rPr lang="en-US" sz="1400" dirty="0">
                      <a:ea typeface="MS PGothic" charset="0"/>
                      <a:cs typeface="MS PGothic" charset="0"/>
                    </a:rPr>
                    <a:t>Day 0</a:t>
                  </a:r>
                </a:p>
              </p:txBody>
            </p:sp>
            <p:sp>
              <p:nvSpPr>
                <p:cNvPr id="22" name="TextBox 18"/>
                <p:cNvSpPr txBox="1">
                  <a:spLocks noChangeArrowheads="1"/>
                </p:cNvSpPr>
                <p:nvPr/>
              </p:nvSpPr>
              <p:spPr bwMode="auto">
                <a:xfrm>
                  <a:off x="4287589" y="5462292"/>
                  <a:ext cx="798519" cy="28176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5pPr>
                  <a:lvl6pPr marL="25146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6pPr>
                  <a:lvl7pPr marL="29718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7pPr>
                  <a:lvl8pPr marL="34290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8pPr>
                  <a:lvl9pPr marL="3886200" indent="-2286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charset="0"/>
                      <a:ea typeface="ＭＳ Ｐゴシック" charset="0"/>
                    </a:defRPr>
                  </a:lvl9pPr>
                </a:lstStyle>
                <a:p>
                  <a:endParaRPr lang="en-US" sz="1400" dirty="0">
                    <a:ea typeface="MS PGothic" charset="0"/>
                    <a:cs typeface="MS PGothic" charset="0"/>
                  </a:endParaRPr>
                </a:p>
              </p:txBody>
            </p:sp>
          </p:grpSp>
          <p:sp>
            <p:nvSpPr>
              <p:cNvPr id="10" name="TextBox 9"/>
              <p:cNvSpPr txBox="1">
                <a:spLocks noChangeArrowheads="1"/>
              </p:cNvSpPr>
              <p:nvPr/>
            </p:nvSpPr>
            <p:spPr bwMode="auto">
              <a:xfrm>
                <a:off x="3545958" y="1030051"/>
                <a:ext cx="3723063" cy="55399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charset="0"/>
                    <a:ea typeface="ＭＳ Ｐゴシック" charset="0"/>
                  </a:defRPr>
                </a:lvl9pPr>
              </a:lstStyle>
              <a:p>
                <a:r>
                  <a:rPr lang="en-US" sz="1400" b="1" dirty="0">
                    <a:ea typeface="MS PGothic" charset="0"/>
                    <a:cs typeface="MS PGothic" charset="0"/>
                  </a:rPr>
                  <a:t>Evaluate:</a:t>
                </a:r>
              </a:p>
              <a:p>
                <a:r>
                  <a:rPr lang="en-US" sz="1400" b="1" dirty="0">
                    <a:ea typeface="MS PGothic" charset="0"/>
                    <a:cs typeface="MS PGothic" charset="0"/>
                  </a:rPr>
                  <a:t>Collect blood on week 2, 4, 6, 8, 12, and 24 </a:t>
                </a:r>
                <a:r>
                  <a:rPr lang="en-US" sz="1600" b="1" dirty="0">
                    <a:ea typeface="MS PGothic" charset="0"/>
                    <a:cs typeface="MS PGothic" charset="0"/>
                  </a:rPr>
                  <a:t>(  )</a:t>
                </a:r>
              </a:p>
            </p:txBody>
          </p:sp>
          <p:cxnSp>
            <p:nvCxnSpPr>
              <p:cNvPr id="11" name="Straight Connector 10"/>
              <p:cNvCxnSpPr/>
              <p:nvPr/>
            </p:nvCxnSpPr>
            <p:spPr bwMode="auto">
              <a:xfrm>
                <a:off x="1649852" y="599827"/>
                <a:ext cx="0" cy="499411"/>
              </a:xfrm>
              <a:prstGeom prst="line">
                <a:avLst/>
              </a:prstGeom>
              <a:ln w="50800" cap="rnd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" name="Rectangle 12"/>
              <p:cNvSpPr/>
              <p:nvPr/>
            </p:nvSpPr>
            <p:spPr>
              <a:xfrm>
                <a:off x="1680773" y="1592209"/>
                <a:ext cx="1551771" cy="3428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400" b="1" dirty="0">
                    <a:ea typeface="MS PGothic" charset="0"/>
                    <a:cs typeface="MS PGothic" charset="0"/>
                  </a:rPr>
                  <a:t>Hybrid Vaccine </a:t>
                </a:r>
                <a:r>
                  <a:rPr lang="en-US" sz="1600" b="1" dirty="0">
                    <a:ea typeface="MS PGothic" charset="0"/>
                    <a:cs typeface="MS PGothic" charset="0"/>
                  </a:rPr>
                  <a:t>(  )</a:t>
                </a:r>
                <a:endParaRPr lang="en-US" sz="1600" dirty="0">
                  <a:ea typeface="MS PGothic" charset="0"/>
                  <a:cs typeface="MS PGothic" charset="0"/>
                </a:endParaRPr>
              </a:p>
            </p:txBody>
          </p:sp>
          <p:cxnSp>
            <p:nvCxnSpPr>
              <p:cNvPr id="14" name="Straight Connector 13"/>
              <p:cNvCxnSpPr>
                <a:cxnSpLocks/>
              </p:cNvCxnSpPr>
              <p:nvPr/>
            </p:nvCxnSpPr>
            <p:spPr bwMode="auto">
              <a:xfrm>
                <a:off x="3014080" y="1680653"/>
                <a:ext cx="0" cy="176196"/>
              </a:xfrm>
              <a:prstGeom prst="line">
                <a:avLst/>
              </a:prstGeom>
              <a:ln w="50800" cap="rnd">
                <a:solidFill>
                  <a:schemeClr val="accent6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6" name="Straight Connector 5"/>
            <p:cNvCxnSpPr/>
            <p:nvPr/>
          </p:nvCxnSpPr>
          <p:spPr bwMode="auto">
            <a:xfrm>
              <a:off x="3161722" y="2071612"/>
              <a:ext cx="0" cy="551457"/>
            </a:xfrm>
            <a:prstGeom prst="line">
              <a:avLst/>
            </a:prstGeom>
            <a:ln w="38100">
              <a:solidFill>
                <a:srgbClr val="008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8" name="TextBox 18">
            <a:extLst>
              <a:ext uri="{FF2B5EF4-FFF2-40B4-BE49-F238E27FC236}">
                <a16:creationId xmlns:a16="http://schemas.microsoft.com/office/drawing/2014/main" id="{4407072B-AF3C-2949-9DB6-8B2B9D8FB04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813640" y="1789213"/>
            <a:ext cx="108810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sz="1400" dirty="0">
                <a:ea typeface="MS PGothic" charset="0"/>
                <a:cs typeface="MS PGothic" charset="0"/>
              </a:rPr>
              <a:t>Week 24</a:t>
            </a:r>
          </a:p>
        </p:txBody>
      </p:sp>
      <p:sp>
        <p:nvSpPr>
          <p:cNvPr id="31" name="TextBox 17">
            <a:extLst>
              <a:ext uri="{FF2B5EF4-FFF2-40B4-BE49-F238E27FC236}">
                <a16:creationId xmlns:a16="http://schemas.microsoft.com/office/drawing/2014/main" id="{08817D2E-00DA-41E1-9826-5FDD1498A3A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095187" y="1789213"/>
            <a:ext cx="864608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sz="1400" dirty="0" err="1">
                <a:ea typeface="MS PGothic" charset="0"/>
                <a:cs typeface="MS PGothic" charset="0"/>
              </a:rPr>
              <a:t>Wk</a:t>
            </a:r>
            <a:r>
              <a:rPr lang="en-US" sz="1400" dirty="0">
                <a:ea typeface="MS PGothic" charset="0"/>
                <a:cs typeface="MS PGothic" charset="0"/>
              </a:rPr>
              <a:t> 12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0FA54DC-206A-4DCA-9F4C-3A73EDDA635A}"/>
              </a:ext>
            </a:extLst>
          </p:cNvPr>
          <p:cNvSpPr txBox="1"/>
          <p:nvPr/>
        </p:nvSpPr>
        <p:spPr>
          <a:xfrm>
            <a:off x="2596865" y="3775976"/>
            <a:ext cx="6327253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S3. Design for VLP vaccination in BALB/c mice. </a:t>
            </a:r>
            <a:r>
              <a:rPr lang="en-US" dirty="0"/>
              <a:t> BALB/c mice (2-3 months old) administered with hybrid vaccine in PBS via subcutaneous (study 1) or intramuscular (study 2) route. Control mice received either PBS or influenza VLP. Purified GPI-RBD-GM-CSF fusion protein or RBD also administered for some groups. Booster dose was given 2 weeks after the first dose. </a:t>
            </a:r>
          </a:p>
        </p:txBody>
      </p:sp>
      <p:sp>
        <p:nvSpPr>
          <p:cNvPr id="30" name="Teardrop 29">
            <a:extLst>
              <a:ext uri="{FF2B5EF4-FFF2-40B4-BE49-F238E27FC236}">
                <a16:creationId xmlns:a16="http://schemas.microsoft.com/office/drawing/2014/main" id="{22ABBB36-F571-4AB5-9827-66437F318B00}"/>
              </a:ext>
            </a:extLst>
          </p:cNvPr>
          <p:cNvSpPr/>
          <p:nvPr/>
        </p:nvSpPr>
        <p:spPr>
          <a:xfrm>
            <a:off x="5084707" y="2243839"/>
            <a:ext cx="106997" cy="125871"/>
          </a:xfrm>
          <a:prstGeom prst="teardrop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TextBox 17"/>
          <p:cNvSpPr txBox="1">
            <a:spLocks noChangeArrowheads="1"/>
          </p:cNvSpPr>
          <p:nvPr/>
        </p:nvSpPr>
        <p:spPr bwMode="auto">
          <a:xfrm>
            <a:off x="4136796" y="1789213"/>
            <a:ext cx="864608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sz="1400" dirty="0" err="1">
                <a:ea typeface="MS PGothic" charset="0"/>
                <a:cs typeface="MS PGothic" charset="0"/>
              </a:rPr>
              <a:t>Wk</a:t>
            </a:r>
            <a:r>
              <a:rPr lang="en-US" sz="1400" dirty="0">
                <a:ea typeface="MS PGothic" charset="0"/>
                <a:cs typeface="MS PGothic" charset="0"/>
              </a:rPr>
              <a:t> 2</a:t>
            </a:r>
          </a:p>
        </p:txBody>
      </p:sp>
      <p:sp>
        <p:nvSpPr>
          <p:cNvPr id="33" name="TextBox 17"/>
          <p:cNvSpPr txBox="1">
            <a:spLocks noChangeArrowheads="1"/>
          </p:cNvSpPr>
          <p:nvPr/>
        </p:nvSpPr>
        <p:spPr bwMode="auto">
          <a:xfrm>
            <a:off x="5773088" y="1789213"/>
            <a:ext cx="864608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sz="1400" dirty="0" err="1">
                <a:ea typeface="MS PGothic" charset="0"/>
                <a:cs typeface="MS PGothic" charset="0"/>
              </a:rPr>
              <a:t>Wk</a:t>
            </a:r>
            <a:r>
              <a:rPr lang="en-US" sz="1400" dirty="0">
                <a:ea typeface="MS PGothic" charset="0"/>
                <a:cs typeface="MS PGothic" charset="0"/>
              </a:rPr>
              <a:t> 6</a:t>
            </a:r>
          </a:p>
        </p:txBody>
      </p:sp>
      <p:sp>
        <p:nvSpPr>
          <p:cNvPr id="37" name="TextBox 17"/>
          <p:cNvSpPr txBox="1">
            <a:spLocks noChangeArrowheads="1"/>
          </p:cNvSpPr>
          <p:nvPr/>
        </p:nvSpPr>
        <p:spPr bwMode="auto">
          <a:xfrm>
            <a:off x="6434827" y="1789213"/>
            <a:ext cx="864608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sz="1400" dirty="0" err="1">
                <a:ea typeface="MS PGothic" charset="0"/>
                <a:cs typeface="MS PGothic" charset="0"/>
              </a:rPr>
              <a:t>Wk</a:t>
            </a:r>
            <a:r>
              <a:rPr lang="en-US" sz="1400" dirty="0">
                <a:ea typeface="MS PGothic" charset="0"/>
                <a:cs typeface="MS PGothic" charset="0"/>
              </a:rPr>
              <a:t> 8</a:t>
            </a:r>
          </a:p>
        </p:txBody>
      </p:sp>
      <p:sp>
        <p:nvSpPr>
          <p:cNvPr id="38" name="TextBox 17"/>
          <p:cNvSpPr txBox="1">
            <a:spLocks noChangeArrowheads="1"/>
          </p:cNvSpPr>
          <p:nvPr/>
        </p:nvSpPr>
        <p:spPr bwMode="auto">
          <a:xfrm>
            <a:off x="4934892" y="1789213"/>
            <a:ext cx="864608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sz="1400" dirty="0" err="1">
                <a:ea typeface="MS PGothic" charset="0"/>
                <a:cs typeface="MS PGothic" charset="0"/>
              </a:rPr>
              <a:t>Wk</a:t>
            </a:r>
            <a:r>
              <a:rPr lang="en-US" sz="1400" dirty="0">
                <a:ea typeface="MS PGothic" charset="0"/>
                <a:cs typeface="MS PGothic" charset="0"/>
              </a:rPr>
              <a:t> 4</a:t>
            </a:r>
          </a:p>
        </p:txBody>
      </p:sp>
      <p:sp>
        <p:nvSpPr>
          <p:cNvPr id="39" name="Teardrop 38">
            <a:extLst>
              <a:ext uri="{FF2B5EF4-FFF2-40B4-BE49-F238E27FC236}">
                <a16:creationId xmlns:a16="http://schemas.microsoft.com/office/drawing/2014/main" id="{22ABBB36-F571-4AB5-9827-66437F318B00}"/>
              </a:ext>
            </a:extLst>
          </p:cNvPr>
          <p:cNvSpPr/>
          <p:nvPr/>
        </p:nvSpPr>
        <p:spPr>
          <a:xfrm>
            <a:off x="5995094" y="2243839"/>
            <a:ext cx="106997" cy="125871"/>
          </a:xfrm>
          <a:prstGeom prst="teardrop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Teardrop 39">
            <a:extLst>
              <a:ext uri="{FF2B5EF4-FFF2-40B4-BE49-F238E27FC236}">
                <a16:creationId xmlns:a16="http://schemas.microsoft.com/office/drawing/2014/main" id="{22ABBB36-F571-4AB5-9827-66437F318B00}"/>
              </a:ext>
            </a:extLst>
          </p:cNvPr>
          <p:cNvSpPr/>
          <p:nvPr/>
        </p:nvSpPr>
        <p:spPr>
          <a:xfrm>
            <a:off x="6580643" y="2243839"/>
            <a:ext cx="106997" cy="125871"/>
          </a:xfrm>
          <a:prstGeom prst="teardrop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Teardrop 40">
            <a:extLst>
              <a:ext uri="{FF2B5EF4-FFF2-40B4-BE49-F238E27FC236}">
                <a16:creationId xmlns:a16="http://schemas.microsoft.com/office/drawing/2014/main" id="{22ABBB36-F571-4AB5-9827-66437F318B00}"/>
              </a:ext>
            </a:extLst>
          </p:cNvPr>
          <p:cNvSpPr/>
          <p:nvPr/>
        </p:nvSpPr>
        <p:spPr>
          <a:xfrm>
            <a:off x="7334629" y="2243839"/>
            <a:ext cx="106997" cy="125871"/>
          </a:xfrm>
          <a:prstGeom prst="teardrop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Teardrop 41">
            <a:extLst>
              <a:ext uri="{FF2B5EF4-FFF2-40B4-BE49-F238E27FC236}">
                <a16:creationId xmlns:a16="http://schemas.microsoft.com/office/drawing/2014/main" id="{22ABBB36-F571-4AB5-9827-66437F318B00}"/>
              </a:ext>
            </a:extLst>
          </p:cNvPr>
          <p:cNvSpPr/>
          <p:nvPr/>
        </p:nvSpPr>
        <p:spPr>
          <a:xfrm>
            <a:off x="8088615" y="2243839"/>
            <a:ext cx="106997" cy="125871"/>
          </a:xfrm>
          <a:prstGeom prst="teardrop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" name="Teardrop 42">
            <a:extLst>
              <a:ext uri="{FF2B5EF4-FFF2-40B4-BE49-F238E27FC236}">
                <a16:creationId xmlns:a16="http://schemas.microsoft.com/office/drawing/2014/main" id="{22ABBB36-F571-4AB5-9827-66437F318B00}"/>
              </a:ext>
            </a:extLst>
          </p:cNvPr>
          <p:cNvSpPr/>
          <p:nvPr/>
        </p:nvSpPr>
        <p:spPr>
          <a:xfrm>
            <a:off x="4214420" y="2243839"/>
            <a:ext cx="106997" cy="125871"/>
          </a:xfrm>
          <a:prstGeom prst="teardrop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" name="Teardrop 43">
            <a:extLst>
              <a:ext uri="{FF2B5EF4-FFF2-40B4-BE49-F238E27FC236}">
                <a16:creationId xmlns:a16="http://schemas.microsoft.com/office/drawing/2014/main" id="{22ABBB36-F571-4AB5-9827-66437F318B00}"/>
              </a:ext>
            </a:extLst>
          </p:cNvPr>
          <p:cNvSpPr/>
          <p:nvPr/>
        </p:nvSpPr>
        <p:spPr>
          <a:xfrm>
            <a:off x="8333233" y="2869476"/>
            <a:ext cx="106997" cy="125871"/>
          </a:xfrm>
          <a:prstGeom prst="teardrop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108032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00576291"/>
              </p:ext>
            </p:extLst>
          </p:nvPr>
        </p:nvGraphicFramePr>
        <p:xfrm>
          <a:off x="2797175" y="711268"/>
          <a:ext cx="5541963" cy="38179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3928721" imgH="2707638" progId="Prism9.Document">
                  <p:embed/>
                </p:oleObj>
              </mc:Choice>
              <mc:Fallback>
                <p:oleObj name="Prism 9" r:id="rId2" imgW="3928721" imgH="2707638" progId="Prism9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797175" y="711268"/>
                        <a:ext cx="5541963" cy="38179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578926" y="4552033"/>
            <a:ext cx="11062614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S4. Booster dose induces high titers of anti-RBD antibody. </a:t>
            </a:r>
            <a:r>
              <a:rPr lang="en-US" dirty="0"/>
              <a:t>Mice were administered with 10 µg/dose of hybrid vaccine containing VLP, GPI-RBD-GM-CSF and GPI-IL-12 subcutaneously. Blood was collected after 2 weeks, and the following day booster dose was given. Blood was collected 2 weeks and 4 weeks after the booster dose (4 weeks and 6 weeks after the first dose). CHO-S cell transfectants expressing GPI-RBD-GM-CSF were used for detection of antibody by flow cytometry. FITC-conjugated anti-mouse IgM/IgG secondary antibody was used.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251632" y="1084307"/>
            <a:ext cx="17172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(before booster)</a:t>
            </a:r>
          </a:p>
        </p:txBody>
      </p:sp>
    </p:spTree>
    <p:extLst>
      <p:ext uri="{BB962C8B-B14F-4D97-AF65-F5344CB8AC3E}">
        <p14:creationId xmlns:p14="http://schemas.microsoft.com/office/powerpoint/2010/main" val="147818043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538D40F9-D44B-47A4-A960-B424122DE54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865" r="15468" b="27835"/>
          <a:stretch/>
        </p:blipFill>
        <p:spPr>
          <a:xfrm>
            <a:off x="6386052" y="1529730"/>
            <a:ext cx="2623477" cy="2719542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7981CA58-2178-4E05-8D08-AE3D0F76CC25}"/>
              </a:ext>
            </a:extLst>
          </p:cNvPr>
          <p:cNvSpPr txBox="1"/>
          <p:nvPr/>
        </p:nvSpPr>
        <p:spPr>
          <a:xfrm>
            <a:off x="7339689" y="3470382"/>
            <a:ext cx="9291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Unstained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A20F5F3-DDD3-43D4-B405-B2E773B1BD38}"/>
              </a:ext>
            </a:extLst>
          </p:cNvPr>
          <p:cNvSpPr txBox="1"/>
          <p:nvPr/>
        </p:nvSpPr>
        <p:spPr>
          <a:xfrm>
            <a:off x="7418504" y="3243706"/>
            <a:ext cx="10166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2oAb alone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80D87637-77D5-4191-806F-F92650A23F1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4259" r="3121" b="27979"/>
          <a:stretch/>
        </p:blipFill>
        <p:spPr>
          <a:xfrm>
            <a:off x="3644154" y="1529730"/>
            <a:ext cx="2429570" cy="2719542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CCEF5466-B7B2-413F-B644-D80ED738CB1F}"/>
              </a:ext>
            </a:extLst>
          </p:cNvPr>
          <p:cNvSpPr txBox="1"/>
          <p:nvPr/>
        </p:nvSpPr>
        <p:spPr>
          <a:xfrm>
            <a:off x="6763712" y="1326334"/>
            <a:ext cx="20778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Intramuscular (</a:t>
            </a:r>
            <a:r>
              <a:rPr lang="en-US" sz="1400" dirty="0"/>
              <a:t>Study 2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63B1B2E-31AA-47BD-A5B9-298E2626FCA2}"/>
              </a:ext>
            </a:extLst>
          </p:cNvPr>
          <p:cNvSpPr txBox="1"/>
          <p:nvPr/>
        </p:nvSpPr>
        <p:spPr>
          <a:xfrm>
            <a:off x="4453465" y="3439900"/>
            <a:ext cx="9291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Unstained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F11EC9C-FB55-4D89-A0DA-10A07297A280}"/>
              </a:ext>
            </a:extLst>
          </p:cNvPr>
          <p:cNvSpPr txBox="1"/>
          <p:nvPr/>
        </p:nvSpPr>
        <p:spPr>
          <a:xfrm>
            <a:off x="4532280" y="3213224"/>
            <a:ext cx="10166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2oAb alone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328257" y="4316869"/>
            <a:ext cx="9238213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S5. VLP vaccine administration subcutaneously or intramuscularly induces comparable levels of antibody against RBD. </a:t>
            </a:r>
            <a:r>
              <a:rPr lang="en-US" dirty="0"/>
              <a:t>Mice (n=5) were administered with 10 µg hybrid vaccine containing GPI-RBD-GM-CSF and GPI-IL-12 either subcutaneous (left) or intramuscular (right) route. Booster dose was given 2 weeks later, and blood was collected 2 weeks after the booster dose (4 weeks after the first dose). CHO-S cell transfectants expressing GPI-RBD-GM-CSF were used for detection of serum antibody (1:100 dilution) by flow cytometry. FITC-conjugated anti-mouse IgM/IgG secondary antibody was used.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CEF5466-B7B2-413F-B644-D80ED738CB1F}"/>
              </a:ext>
            </a:extLst>
          </p:cNvPr>
          <p:cNvSpPr txBox="1"/>
          <p:nvPr/>
        </p:nvSpPr>
        <p:spPr>
          <a:xfrm>
            <a:off x="3823065" y="1382147"/>
            <a:ext cx="21242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bcutaneous (</a:t>
            </a:r>
            <a:r>
              <a:rPr lang="en-US" sz="1400" dirty="0"/>
              <a:t>Study 1)</a:t>
            </a:r>
          </a:p>
        </p:txBody>
      </p:sp>
    </p:spTree>
    <p:extLst>
      <p:ext uri="{BB962C8B-B14F-4D97-AF65-F5344CB8AC3E}">
        <p14:creationId xmlns:p14="http://schemas.microsoft.com/office/powerpoint/2010/main" val="168174634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/>
          <p:cNvSpPr txBox="1"/>
          <p:nvPr/>
        </p:nvSpPr>
        <p:spPr>
          <a:xfrm>
            <a:off x="1435519" y="4557764"/>
            <a:ext cx="9612440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S6</a:t>
            </a:r>
            <a:r>
              <a:rPr lang="en-US" dirty="0"/>
              <a:t>. </a:t>
            </a:r>
            <a:r>
              <a:rPr lang="en-US" b="1" dirty="0"/>
              <a:t>Hybrid vaccine induces RBD specific antibody response. </a:t>
            </a:r>
            <a:r>
              <a:rPr lang="en-US" dirty="0"/>
              <a:t>Mice were administered with 10 µg VLP vaccine containing GPI-IL-12 and either GPI-GM-CSF or GPI-RBD-GM-CSF subcutaneous route. A booster dose was given 2 weeks later, and blood was collected 2 weeks after the booster dose (4 weeks after the first dose). CHO S cells (left) or CHO S transfectants expressing GPI-RBD-GM-CSF (right) were used for detection of serum antibody (1:50 dilution) by flow cytometry. FITC-conjugated anti-mouse IgM/IgG secondary antibody was used.</a:t>
            </a:r>
          </a:p>
        </p:txBody>
      </p:sp>
      <p:grpSp>
        <p:nvGrpSpPr>
          <p:cNvPr id="15" name="Group 14"/>
          <p:cNvGrpSpPr/>
          <p:nvPr/>
        </p:nvGrpSpPr>
        <p:grpSpPr>
          <a:xfrm>
            <a:off x="2773180" y="474531"/>
            <a:ext cx="5256395" cy="4202834"/>
            <a:chOff x="3752850" y="909062"/>
            <a:chExt cx="4276725" cy="3562350"/>
          </a:xfrm>
        </p:grpSpPr>
        <p:graphicFrame>
          <p:nvGraphicFramePr>
            <p:cNvPr id="16" name="Object 1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681481355"/>
                </p:ext>
              </p:extLst>
            </p:nvPr>
          </p:nvGraphicFramePr>
          <p:xfrm>
            <a:off x="3752850" y="909062"/>
            <a:ext cx="4276725" cy="35623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2" imgW="4276612" imgH="3563004" progId="Prism9.Document">
                    <p:embed/>
                  </p:oleObj>
                </mc:Choice>
                <mc:Fallback>
                  <p:oleObj name="Prism 9" r:id="rId2" imgW="4276612" imgH="3563004" progId="Prism9.Document">
                    <p:embed/>
                    <p:pic>
                      <p:nvPicPr>
                        <p:cNvPr id="2" name="Object 1"/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3752850" y="909062"/>
                          <a:ext cx="4276725" cy="35623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cxnSp>
          <p:nvCxnSpPr>
            <p:cNvPr id="17" name="Straight Connector 16"/>
            <p:cNvCxnSpPr/>
            <p:nvPr/>
          </p:nvCxnSpPr>
          <p:spPr>
            <a:xfrm rot="5400000">
              <a:off x="4949605" y="2048581"/>
              <a:ext cx="1897039" cy="0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8" name="TextBox 17"/>
          <p:cNvSpPr txBox="1"/>
          <p:nvPr/>
        </p:nvSpPr>
        <p:spPr>
          <a:xfrm>
            <a:off x="6074552" y="3668593"/>
            <a:ext cx="391004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Hybrid vaccine: 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VLP-GPI-RBD-GM-CSF + GPI-IL-12</a:t>
            </a:r>
          </a:p>
        </p:txBody>
      </p:sp>
    </p:spTree>
    <p:extLst>
      <p:ext uri="{BB962C8B-B14F-4D97-AF65-F5344CB8AC3E}">
        <p14:creationId xmlns:p14="http://schemas.microsoft.com/office/powerpoint/2010/main" val="89782921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6954414"/>
              </p:ext>
            </p:extLst>
          </p:nvPr>
        </p:nvGraphicFramePr>
        <p:xfrm>
          <a:off x="1728788" y="1309688"/>
          <a:ext cx="4614862" cy="4594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3582630" imgH="3567686" progId="Prism9.Document">
                  <p:embed/>
                </p:oleObj>
              </mc:Choice>
              <mc:Fallback>
                <p:oleObj name="Prism 9" r:id="rId2" imgW="3582630" imgH="3567686" progId="Prism9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728788" y="1309688"/>
                        <a:ext cx="4614862" cy="45942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5" name="Straight Connector 4"/>
          <p:cNvCxnSpPr/>
          <p:nvPr/>
        </p:nvCxnSpPr>
        <p:spPr>
          <a:xfrm>
            <a:off x="5114830" y="4938066"/>
            <a:ext cx="870155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6730878" y="1876309"/>
            <a:ext cx="5136628" cy="3416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S7</a:t>
            </a:r>
            <a:r>
              <a:rPr lang="en-US" dirty="0"/>
              <a:t>. </a:t>
            </a:r>
            <a:r>
              <a:rPr lang="en-US" b="1" dirty="0"/>
              <a:t>VLP vaccine-induced antibody blocks ACE-2 binding to RBD. </a:t>
            </a:r>
            <a:r>
              <a:rPr lang="en-US" dirty="0"/>
              <a:t>Mice administered with GPI-RBD-GM-CSF protein or hybrid vaccine subcutaneous route. Booster dose given 2 weeks later, and blood collected 6 weeks after the booster dose (8 weeks after the first dose). CHO S cell transfectants were incubated with diluted plasma or MM57 mAb followed by biotinylated ACE-2 (3 µg/ml). FITC-conjugated streptavidin (1:50 dilution) used for detecting the cell surface RBD-bound ACE-2.</a:t>
            </a:r>
          </a:p>
          <a:p>
            <a:r>
              <a:rPr lang="en-US" dirty="0"/>
              <a:t> Hybrid vaccine: VLP incorporated with GPI-RBD-GM-CSF and GPI-IL-12</a:t>
            </a:r>
          </a:p>
        </p:txBody>
      </p:sp>
      <p:cxnSp>
        <p:nvCxnSpPr>
          <p:cNvPr id="8" name="Straight Connector 7"/>
          <p:cNvCxnSpPr/>
          <p:nvPr/>
        </p:nvCxnSpPr>
        <p:spPr>
          <a:xfrm>
            <a:off x="5195173" y="2020521"/>
            <a:ext cx="0" cy="2109019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54576413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41530951"/>
              </p:ext>
            </p:extLst>
          </p:nvPr>
        </p:nvGraphicFramePr>
        <p:xfrm>
          <a:off x="5037138" y="657847"/>
          <a:ext cx="4164603" cy="333788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3056832" imgH="2451569" progId="Prism9.Document">
                  <p:embed/>
                </p:oleObj>
              </mc:Choice>
              <mc:Fallback>
                <p:oleObj name="Prism 9" r:id="rId2" imgW="3056832" imgH="2451569" progId="Prism9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037138" y="657847"/>
                        <a:ext cx="4164603" cy="333788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6" name="TextBox 15"/>
          <p:cNvSpPr txBox="1"/>
          <p:nvPr/>
        </p:nvSpPr>
        <p:spPr>
          <a:xfrm>
            <a:off x="875730" y="4585675"/>
            <a:ext cx="10138634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8. Hybrid vaccine but not the purified RBD-GM-CSF induces SARS-CoV-2 neutralizing antibody.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(A) Antibody levels in the plasma detected by flow cytometry using CHO-S cells as described in Methods. (B)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Microneutralization of SARS-CoV-2 infection using Vero.E6 cells performed by pre-incubating the WA11 strain of SARS-CoV-2 with serially diluted heat-inactivated plasma samples as described in Methods. Week 12 plasma used for antibody binding (A), and neutralizing antibody titer (B) analysis. FRNT: 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ocus Reduction Neutralization Titer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2" name="Objec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52026036"/>
              </p:ext>
            </p:extLst>
          </p:nvPr>
        </p:nvGraphicFramePr>
        <p:xfrm>
          <a:off x="765175" y="982656"/>
          <a:ext cx="4527550" cy="30972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4038562" imgH="2761922" progId="Prism9.Document">
                  <p:embed/>
                </p:oleObj>
              </mc:Choice>
              <mc:Fallback>
                <p:oleObj name="Prism 9" r:id="rId4" imgW="4038562" imgH="2761922" progId="Prism9.Document">
                  <p:embed/>
                  <p:pic>
                    <p:nvPicPr>
                      <p:cNvPr id="3" name="Object 2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765175" y="982656"/>
                        <a:ext cx="4527550" cy="30972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788522" y="3393689"/>
            <a:ext cx="9735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Symbol" panose="05050102010706020507" pitchFamily="18" charset="2"/>
              </a:rPr>
              <a:t>m</a:t>
            </a:r>
            <a:r>
              <a:rPr lang="en-US" dirty="0"/>
              <a:t>g/dose</a:t>
            </a:r>
          </a:p>
        </p:txBody>
      </p:sp>
      <p:cxnSp>
        <p:nvCxnSpPr>
          <p:cNvPr id="8" name="Straight Connector 7"/>
          <p:cNvCxnSpPr/>
          <p:nvPr/>
        </p:nvCxnSpPr>
        <p:spPr>
          <a:xfrm>
            <a:off x="1757512" y="3697951"/>
            <a:ext cx="82191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>
            <a:off x="3138156" y="3697951"/>
            <a:ext cx="137842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3739487" y="834138"/>
            <a:ext cx="9076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ilution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B29C0CB-C922-4385-B2CC-ED7873DE1FA6}"/>
              </a:ext>
            </a:extLst>
          </p:cNvPr>
          <p:cNvSpPr txBox="1"/>
          <p:nvPr/>
        </p:nvSpPr>
        <p:spPr>
          <a:xfrm>
            <a:off x="1457962" y="333265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A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9FCD04E-76AC-4826-91C9-8181F2CB0FA6}"/>
              </a:ext>
            </a:extLst>
          </p:cNvPr>
          <p:cNvSpPr txBox="1"/>
          <p:nvPr/>
        </p:nvSpPr>
        <p:spPr>
          <a:xfrm>
            <a:off x="6092696" y="333265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B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5219272" y="3578125"/>
            <a:ext cx="9879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µg/dose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6206639" y="3570737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6686591" y="3570737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5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8049582" y="3570737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0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7160384" y="3570737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7653984" y="3570737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5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6142008" y="3938581"/>
            <a:ext cx="98796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GPI-RBD-GM-CSF</a:t>
            </a:r>
          </a:p>
        </p:txBody>
      </p:sp>
      <p:cxnSp>
        <p:nvCxnSpPr>
          <p:cNvPr id="10" name="Straight Connector 9"/>
          <p:cNvCxnSpPr>
            <a:cxnSpLocks/>
          </p:cNvCxnSpPr>
          <p:nvPr/>
        </p:nvCxnSpPr>
        <p:spPr>
          <a:xfrm>
            <a:off x="6221090" y="3936311"/>
            <a:ext cx="79528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7289137" y="3953089"/>
            <a:ext cx="14952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Hybrid vaccine</a:t>
            </a:r>
          </a:p>
        </p:txBody>
      </p:sp>
      <p:cxnSp>
        <p:nvCxnSpPr>
          <p:cNvPr id="24" name="Straight Connector 23"/>
          <p:cNvCxnSpPr>
            <a:cxnSpLocks/>
          </p:cNvCxnSpPr>
          <p:nvPr/>
        </p:nvCxnSpPr>
        <p:spPr>
          <a:xfrm>
            <a:off x="7213636" y="3936311"/>
            <a:ext cx="133766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6986724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567</TotalTime>
  <Words>1368</Words>
  <Application>Microsoft Office PowerPoint</Application>
  <PresentationFormat>Widescreen</PresentationFormat>
  <Paragraphs>72</Paragraphs>
  <Slides>12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9" baseType="lpstr">
      <vt:lpstr>Arial</vt:lpstr>
      <vt:lpstr>Calibri</vt:lpstr>
      <vt:lpstr>Calibri Light</vt:lpstr>
      <vt:lpstr>Symbol</vt:lpstr>
      <vt:lpstr>Times New Roman</vt:lpstr>
      <vt:lpstr>Office Theme</vt:lpstr>
      <vt:lpstr>Prism 9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Emory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ommireddy, Ramireddy</dc:creator>
  <cp:lastModifiedBy>Bommireddy, Ramireddy</cp:lastModifiedBy>
  <cp:revision>226</cp:revision>
  <cp:lastPrinted>2021-11-22T18:51:29Z</cp:lastPrinted>
  <dcterms:created xsi:type="dcterms:W3CDTF">2021-08-06T14:54:57Z</dcterms:created>
  <dcterms:modified xsi:type="dcterms:W3CDTF">2022-06-11T02:50:48Z</dcterms:modified>
</cp:coreProperties>
</file>